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6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E0B185-94B2-457D-82D8-F0E0DFF285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90153A9-0B6C-A4AB-F7DE-1A3A644709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E99A099-9545-3513-FA51-00EE19733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C5679CD-C092-0ADA-19B8-51926AD23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619154-DB86-C82A-836F-1F9EE547E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9448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016F3A-CB7D-098D-01BD-B8BDF159AB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115B02F-E879-B232-5629-344283B2FD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7DE3E1-5847-1226-9AAD-995D176B6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620C72-CED3-02AA-525F-3654E3EAA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D59DC1-7AF8-2110-F701-1D893DADF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060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9B00FCC-F300-5E8F-F107-64B621DE35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E71481E-A4D6-8C4F-C744-FEF9FDDA90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EDE1F9-801B-D27E-191B-4BB54FD70D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3BBB4C0-5C44-99C4-2E17-2A730A8DB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D0B9476-BFAC-40FA-5374-EB2E20B8D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198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45BF58-6FDF-BB5F-F280-7A9B0E32AC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B1DD9C4-068C-B154-A3E5-3FB9697260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7616EA-2BBC-86B5-F7B1-949C759E3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CEC8B0A-0E84-EA6D-FBBF-8B4FDD64B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410C705-BBBF-C481-892D-0E03C0F26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4645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91A41C-DD66-A374-16F7-E5B972C152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AEA8806-3534-686E-E355-078D7F030C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4ECBC5-46AF-16CC-D48A-3AEBE1B9D0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B42A6E3-C324-3A39-C427-CA404FFEB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6F4C36-EAFF-7E91-409B-B959B915E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792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73A21E-BED8-5A23-C107-632A8D909A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A71B452-3467-3659-F312-62CDB79960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DD934D0-7A2A-29E8-BAA0-98CC97ABCF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655029B-E7B4-6AC7-A7DF-69CDE2AEA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D54DE36-1278-4320-DBF4-E1D3D5BE6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E86C9E6-004A-1AC2-5ECC-034460F5B1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795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6DE5BA-51DA-8F53-B283-171D2CCCCD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BB85B01-462D-2618-FFAA-A755E27FC1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629806D-AB2F-7AEC-7A4F-C67AA80666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FA2CE17-9102-E20A-4C46-E50C87E14C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0FE1FB7-26E0-43C3-E072-50052BD182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8CE2404-0304-4E39-582A-0FF05CB892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A8D37CF-6540-C956-2D2B-A04505C58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78BC96E-B909-1F93-EAC8-D6968E150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5627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6F4838-CAFA-3E7A-36F2-CA01F4BCBF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810EF16-C4EB-FCFA-E6BB-D935C9632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EA6240C-22A6-5429-7F10-B8613A720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DF9B5B7-9610-C45B-282F-D7DE29925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582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A783E23-6564-5852-1AC7-BD5D2C44E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CCE0828-C35D-A2E7-A630-B2EB56D7C6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8BD43F6-F5BD-8512-89A1-A0724D50C1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6496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25A351-C98D-6575-9CF5-04D2A140CB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53822D4-0DAA-9B90-BBC7-EF464ABDB4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BED238B-0B35-7141-0248-50E46B3105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DF16296-588E-4DAA-947A-7B8B6801E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833D87A-5267-FACE-C8DE-864204BAB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82FA64-A5B3-1D73-DFAD-2BEDD69BE2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8961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3347BA-FD4C-08B5-50DE-895B655838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17D83F4-AC36-3A5A-718E-242B7D2680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07D8602-6CC9-8D38-7177-F555127A2E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62EB53-2A26-6A61-DEB9-EF0CF59BB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2956A92-E3C3-B6D5-A83B-06A973502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3147A8-8D19-BB4A-257B-CA20D4D42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616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51BCC30-3B1F-C4B8-7FCA-81BCFD40B0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78EDB4-5B3A-F9BC-77CB-1B6AA13493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EB1E13-7C8A-F448-02F1-AED6FFDD7A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9497DB-61CB-438D-B2CC-F5F4D8A89CF0}" type="datetimeFigureOut">
              <a:rPr kumimoji="1" lang="ja-JP" altLang="en-US" smtClean="0"/>
              <a:t>2024/9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184C09-DBEF-292B-1C8B-38D71044BF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C9D5CA-CED4-0F7D-B8F9-1BCF2D5ED3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6A9C47-0CC5-4510-89A0-D96A7FE49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5857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1748578A-F3ED-92E5-EC22-21F9E6F7DF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675895"/>
              </p:ext>
            </p:extLst>
          </p:nvPr>
        </p:nvGraphicFramePr>
        <p:xfrm>
          <a:off x="376519" y="1557159"/>
          <a:ext cx="11618260" cy="42976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823523">
                  <a:extLst>
                    <a:ext uri="{9D8B030D-6E8A-4147-A177-3AD203B41FA5}">
                      <a16:colId xmlns:a16="http://schemas.microsoft.com/office/drawing/2014/main" val="104938855"/>
                    </a:ext>
                  </a:extLst>
                </a:gridCol>
                <a:gridCol w="5756570">
                  <a:extLst>
                    <a:ext uri="{9D8B030D-6E8A-4147-A177-3AD203B41FA5}">
                      <a16:colId xmlns:a16="http://schemas.microsoft.com/office/drawing/2014/main" val="264697735"/>
                    </a:ext>
                  </a:extLst>
                </a:gridCol>
                <a:gridCol w="1586753">
                  <a:extLst>
                    <a:ext uri="{9D8B030D-6E8A-4147-A177-3AD203B41FA5}">
                      <a16:colId xmlns:a16="http://schemas.microsoft.com/office/drawing/2014/main" val="2183010355"/>
                    </a:ext>
                  </a:extLst>
                </a:gridCol>
                <a:gridCol w="3451414">
                  <a:extLst>
                    <a:ext uri="{9D8B030D-6E8A-4147-A177-3AD203B41FA5}">
                      <a16:colId xmlns:a16="http://schemas.microsoft.com/office/drawing/2014/main" val="740327304"/>
                    </a:ext>
                  </a:extLst>
                </a:gridCol>
              </a:tblGrid>
              <a:tr h="383356">
                <a:tc>
                  <a:txBody>
                    <a:bodyPr/>
                    <a:lstStyle/>
                    <a:p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fr-FR" altLang="ja-JP" sz="1200" dirty="0"/>
                        <a:t>Types of antigen exposure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Date of </a:t>
                      </a:r>
                    </a:p>
                    <a:p>
                      <a:r>
                        <a:rPr kumimoji="1" lang="en-US" altLang="ja-JP" sz="1200" dirty="0"/>
                        <a:t>QASAS analysis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Note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0446679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No.1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Infection: COVID19-Pt1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Sep/2020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First infection in non-vaccinated individual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2603938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2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Infection: COVID19-Pt2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Sep/2020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First infection in non-vaccinated individual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5623688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3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Infection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Sep/2020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First infection in non-vaccinated individual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4118498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4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1</a:t>
                      </a:r>
                      <a:r>
                        <a:rPr kumimoji="1" lang="en-US" altLang="ja-JP" sz="1200" baseline="30000" dirty="0"/>
                        <a:t>st</a:t>
                      </a:r>
                      <a:r>
                        <a:rPr kumimoji="1" lang="en-US" altLang="ja-JP" sz="1200" dirty="0"/>
                        <a:t> Vaccination (monovalent original BNT162b2): BNT162b2 HV1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Apr/2021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Healthy volunteer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16611139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5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2</a:t>
                      </a:r>
                      <a:r>
                        <a:rPr kumimoji="1" lang="en-US" altLang="ja-JP" sz="1200" baseline="30000" dirty="0"/>
                        <a:t>nd</a:t>
                      </a:r>
                      <a:r>
                        <a:rPr kumimoji="1" lang="en-US" altLang="ja-JP" sz="1200" dirty="0"/>
                        <a:t> Vaccination (monovalent original BNT162b2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May/2021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Healthy volunteer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534387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6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4</a:t>
                      </a:r>
                      <a:r>
                        <a:rPr kumimoji="1" lang="en-US" altLang="ja-JP" sz="1200" baseline="30000" dirty="0"/>
                        <a:t>th</a:t>
                      </a:r>
                      <a:r>
                        <a:rPr kumimoji="1" lang="en-US" altLang="ja-JP" sz="1200" dirty="0"/>
                        <a:t> Vaccination (monovalent original mRNA-1273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Sep/2022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Healthy volunteer 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8695911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7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5</a:t>
                      </a:r>
                      <a:r>
                        <a:rPr kumimoji="1" lang="en-US" altLang="ja-JP" sz="1200" baseline="30000" dirty="0"/>
                        <a:t>th</a:t>
                      </a:r>
                      <a:r>
                        <a:rPr kumimoji="1" lang="en-US" altLang="ja-JP" sz="1200" dirty="0"/>
                        <a:t> Vaccination (bivalent original/BA.4/5 BNT162b2): BNT162b2 HV2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v/2022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Healthy volunteer 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31326027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8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fr-FR" altLang="ja-JP" sz="1200" dirty="0"/>
                        <a:t>7</a:t>
                      </a:r>
                      <a:r>
                        <a:rPr kumimoji="1" lang="fr-FR" altLang="ja-JP" sz="1200" baseline="30000" dirty="0"/>
                        <a:t>th</a:t>
                      </a:r>
                      <a:r>
                        <a:rPr kumimoji="1" lang="fr-FR" altLang="ja-JP" sz="1200" dirty="0"/>
                        <a:t> Vaccination (monovalent Omicron XBB.1.5 mRNA-1273.815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Oct/2023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Healthy volunteer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2403270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9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fr-FR" altLang="ja-JP" sz="1200" dirty="0"/>
                        <a:t>6</a:t>
                      </a:r>
                      <a:r>
                        <a:rPr kumimoji="1" lang="fr-FR" altLang="ja-JP" sz="1200" baseline="30000" dirty="0"/>
                        <a:t>th</a:t>
                      </a:r>
                      <a:r>
                        <a:rPr kumimoji="1" lang="fr-FR" altLang="ja-JP" sz="1200" dirty="0"/>
                        <a:t> Vaccination (monovalent Omicron XBB.1.5 BNT162b2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Sep/2023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Healthy volunteer 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8615421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10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fr-FR" altLang="ja-JP" sz="1200" dirty="0"/>
                        <a:t>6</a:t>
                      </a:r>
                      <a:r>
                        <a:rPr kumimoji="1" lang="fr-FR" altLang="ja-JP" sz="1200" baseline="30000" dirty="0"/>
                        <a:t>th</a:t>
                      </a:r>
                      <a:r>
                        <a:rPr kumimoji="1" lang="fr-FR" altLang="ja-JP" sz="1200" dirty="0"/>
                        <a:t> Vaccination (monovalent Omicron XBB.1.5 BNT162b2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Sep/2023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Healthy volunteer 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1510773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11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1</a:t>
                      </a:r>
                      <a:r>
                        <a:rPr kumimoji="1" lang="en-US" altLang="ja-JP" sz="1200" baseline="30000" dirty="0"/>
                        <a:t>st</a:t>
                      </a:r>
                      <a:r>
                        <a:rPr kumimoji="1" lang="en-US" altLang="ja-JP" sz="1200" dirty="0"/>
                        <a:t> Vaccination (monovalent original BNT162b2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Dec/2022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fr-FR" altLang="ja-JP" sz="1200" dirty="0"/>
                        <a:t>Patient with haematological malignancy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5392675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12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4</a:t>
                      </a:r>
                      <a:r>
                        <a:rPr kumimoji="1" lang="en-US" altLang="ja-JP" sz="1200" baseline="30000" dirty="0"/>
                        <a:t>th</a:t>
                      </a:r>
                      <a:r>
                        <a:rPr kumimoji="1" lang="en-US" altLang="ja-JP" sz="1200" dirty="0"/>
                        <a:t> Vaccination (bivalent original/BA.4/5 BNT162b2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Jun/2023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fr-FR" altLang="ja-JP" sz="1200" dirty="0"/>
                        <a:t>Patient with haematological malignancy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040025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13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4</a:t>
                      </a:r>
                      <a:r>
                        <a:rPr kumimoji="1" lang="en-US" altLang="ja-JP" sz="1200" baseline="30000" dirty="0"/>
                        <a:t>th</a:t>
                      </a:r>
                      <a:r>
                        <a:rPr kumimoji="1" lang="en-US" altLang="ja-JP" sz="1200" dirty="0"/>
                        <a:t> Vaccination </a:t>
                      </a:r>
                      <a:r>
                        <a:rPr kumimoji="1" lang="fr-FR" altLang="ja-JP" sz="1200" dirty="0"/>
                        <a:t>(monovalent Omicron XBB.1.5 BNT162b2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Oct/2023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fr-FR" altLang="ja-JP" sz="1200" dirty="0"/>
                        <a:t>Patient with haematological malignancy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6554624"/>
                  </a:ext>
                </a:extLst>
              </a:tr>
              <a:tr h="23398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No.14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1</a:t>
                      </a:r>
                      <a:r>
                        <a:rPr kumimoji="1" lang="en-US" altLang="ja-JP" sz="1200" baseline="30000" dirty="0"/>
                        <a:t>st</a:t>
                      </a:r>
                      <a:r>
                        <a:rPr kumimoji="1" lang="en-US" altLang="ja-JP" sz="1200" dirty="0"/>
                        <a:t> Vaccination (monovalent original BNT162b2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Dec/2023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fr-FR" altLang="ja-JP" sz="1200" dirty="0"/>
                        <a:t>Patient with haematological malignancy</a:t>
                      </a:r>
                      <a:endParaRPr kumimoji="1" lang="ja-JP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135409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C0526D6-DCD7-CBF1-A1EE-4B30C8F048D0}"/>
              </a:ext>
            </a:extLst>
          </p:cNvPr>
          <p:cNvSpPr txBox="1"/>
          <p:nvPr/>
        </p:nvSpPr>
        <p:spPr>
          <a:xfrm>
            <a:off x="376519" y="972384"/>
            <a:ext cx="11618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fr-FR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Table 1</a:t>
            </a: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ohort exposed to SARS-CoV-2 infection, BNT162b2 and mRNA-1273, which encode SARS-CoV-2 full-length spike protein</a:t>
            </a:r>
          </a:p>
        </p:txBody>
      </p:sp>
    </p:spTree>
    <p:extLst>
      <p:ext uri="{BB962C8B-B14F-4D97-AF65-F5344CB8AC3E}">
        <p14:creationId xmlns:p14="http://schemas.microsoft.com/office/powerpoint/2010/main" val="448079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265</Words>
  <Application>Microsoft Office PowerPoint</Application>
  <PresentationFormat>ワイド画面</PresentationFormat>
  <Paragraphs>6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ohei Funakoshi</dc:creator>
  <cp:lastModifiedBy>Yohei Funakoshi</cp:lastModifiedBy>
  <cp:revision>3</cp:revision>
  <cp:lastPrinted>2024-09-12T15:11:37Z</cp:lastPrinted>
  <dcterms:created xsi:type="dcterms:W3CDTF">2024-07-20T03:42:45Z</dcterms:created>
  <dcterms:modified xsi:type="dcterms:W3CDTF">2024-09-12T15:12:44Z</dcterms:modified>
</cp:coreProperties>
</file>